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648450" cy="85867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63"/>
  </p:normalViewPr>
  <p:slideViewPr>
    <p:cSldViewPr snapToGrid="0" snapToObjects="1">
      <p:cViewPr varScale="1">
        <p:scale>
          <a:sx n="99" d="100"/>
          <a:sy n="99" d="100"/>
        </p:scale>
        <p:origin x="27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98634" y="1405292"/>
            <a:ext cx="5651183" cy="2989474"/>
          </a:xfrm>
        </p:spPr>
        <p:txBody>
          <a:bodyPr anchor="b"/>
          <a:lstStyle>
            <a:lvl1pPr algn="ctr">
              <a:defRPr sz="4363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31056" y="4510052"/>
            <a:ext cx="4986338" cy="2073152"/>
          </a:xfrm>
        </p:spPr>
        <p:txBody>
          <a:bodyPr/>
          <a:lstStyle>
            <a:lvl1pPr marL="0" indent="0" algn="ctr">
              <a:buNone/>
              <a:defRPr sz="1745"/>
            </a:lvl1pPr>
            <a:lvl2pPr marL="332430" indent="0" algn="ctr">
              <a:buNone/>
              <a:defRPr sz="1454"/>
            </a:lvl2pPr>
            <a:lvl3pPr marL="664860" indent="0" algn="ctr">
              <a:buNone/>
              <a:defRPr sz="1309"/>
            </a:lvl3pPr>
            <a:lvl4pPr marL="997290" indent="0" algn="ctr">
              <a:buNone/>
              <a:defRPr sz="1163"/>
            </a:lvl4pPr>
            <a:lvl5pPr marL="1329720" indent="0" algn="ctr">
              <a:buNone/>
              <a:defRPr sz="1163"/>
            </a:lvl5pPr>
            <a:lvl6pPr marL="1662151" indent="0" algn="ctr">
              <a:buNone/>
              <a:defRPr sz="1163"/>
            </a:lvl6pPr>
            <a:lvl7pPr marL="1994581" indent="0" algn="ctr">
              <a:buNone/>
              <a:defRPr sz="1163"/>
            </a:lvl7pPr>
            <a:lvl8pPr marL="2327011" indent="0" algn="ctr">
              <a:buNone/>
              <a:defRPr sz="1163"/>
            </a:lvl8pPr>
            <a:lvl9pPr marL="2659441" indent="0" algn="ctr">
              <a:buNone/>
              <a:defRPr sz="1163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11BCE-92FE-334C-97EE-9DB94685998F}" type="datetimeFigureOut">
              <a:rPr lang="fr-FR" smtClean="0"/>
              <a:t>15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F356F-4C24-8443-96FF-1FFB697E5B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784996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11BCE-92FE-334C-97EE-9DB94685998F}" type="datetimeFigureOut">
              <a:rPr lang="fr-FR" smtClean="0"/>
              <a:t>15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F356F-4C24-8443-96FF-1FFB697E5B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722175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57797" y="457167"/>
            <a:ext cx="1433572" cy="7276906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082" y="457167"/>
            <a:ext cx="4217610" cy="7276906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11BCE-92FE-334C-97EE-9DB94685998F}" type="datetimeFigureOut">
              <a:rPr lang="fr-FR" smtClean="0"/>
              <a:t>15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F356F-4C24-8443-96FF-1FFB697E5B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058267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11BCE-92FE-334C-97EE-9DB94685998F}" type="datetimeFigureOut">
              <a:rPr lang="fr-FR" smtClean="0"/>
              <a:t>15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F356F-4C24-8443-96FF-1FFB697E5B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03732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3619" y="2140736"/>
            <a:ext cx="5734288" cy="3571865"/>
          </a:xfrm>
        </p:spPr>
        <p:txBody>
          <a:bodyPr anchor="b"/>
          <a:lstStyle>
            <a:lvl1pPr>
              <a:defRPr sz="4363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3619" y="5746392"/>
            <a:ext cx="5734288" cy="1878359"/>
          </a:xfrm>
        </p:spPr>
        <p:txBody>
          <a:bodyPr/>
          <a:lstStyle>
            <a:lvl1pPr marL="0" indent="0">
              <a:buNone/>
              <a:defRPr sz="1745">
                <a:solidFill>
                  <a:schemeClr val="tx1"/>
                </a:solidFill>
              </a:defRPr>
            </a:lvl1pPr>
            <a:lvl2pPr marL="332430" indent="0">
              <a:buNone/>
              <a:defRPr sz="1454">
                <a:solidFill>
                  <a:schemeClr val="tx1">
                    <a:tint val="75000"/>
                  </a:schemeClr>
                </a:solidFill>
              </a:defRPr>
            </a:lvl2pPr>
            <a:lvl3pPr marL="664860" indent="0">
              <a:buNone/>
              <a:defRPr sz="1309">
                <a:solidFill>
                  <a:schemeClr val="tx1">
                    <a:tint val="75000"/>
                  </a:schemeClr>
                </a:solidFill>
              </a:defRPr>
            </a:lvl3pPr>
            <a:lvl4pPr marL="997290" indent="0">
              <a:buNone/>
              <a:defRPr sz="1163">
                <a:solidFill>
                  <a:schemeClr val="tx1">
                    <a:tint val="75000"/>
                  </a:schemeClr>
                </a:solidFill>
              </a:defRPr>
            </a:lvl4pPr>
            <a:lvl5pPr marL="1329720" indent="0">
              <a:buNone/>
              <a:defRPr sz="1163">
                <a:solidFill>
                  <a:schemeClr val="tx1">
                    <a:tint val="75000"/>
                  </a:schemeClr>
                </a:solidFill>
              </a:defRPr>
            </a:lvl5pPr>
            <a:lvl6pPr marL="1662151" indent="0">
              <a:buNone/>
              <a:defRPr sz="1163">
                <a:solidFill>
                  <a:schemeClr val="tx1">
                    <a:tint val="75000"/>
                  </a:schemeClr>
                </a:solidFill>
              </a:defRPr>
            </a:lvl6pPr>
            <a:lvl7pPr marL="1994581" indent="0">
              <a:buNone/>
              <a:defRPr sz="1163">
                <a:solidFill>
                  <a:schemeClr val="tx1">
                    <a:tint val="75000"/>
                  </a:schemeClr>
                </a:solidFill>
              </a:defRPr>
            </a:lvl7pPr>
            <a:lvl8pPr marL="2327011" indent="0">
              <a:buNone/>
              <a:defRPr sz="1163">
                <a:solidFill>
                  <a:schemeClr val="tx1">
                    <a:tint val="75000"/>
                  </a:schemeClr>
                </a:solidFill>
              </a:defRPr>
            </a:lvl8pPr>
            <a:lvl9pPr marL="2659441" indent="0">
              <a:buNone/>
              <a:defRPr sz="116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11BCE-92FE-334C-97EE-9DB94685998F}" type="datetimeFigureOut">
              <a:rPr lang="fr-FR" smtClean="0"/>
              <a:t>15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F356F-4C24-8443-96FF-1FFB697E5B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35650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081" y="2285835"/>
            <a:ext cx="2825591" cy="54482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65778" y="2285835"/>
            <a:ext cx="2825591" cy="54482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11BCE-92FE-334C-97EE-9DB94685998F}" type="datetimeFigureOut">
              <a:rPr lang="fr-FR" smtClean="0"/>
              <a:t>15/05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F356F-4C24-8443-96FF-1FFB697E5B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54112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947" y="457169"/>
            <a:ext cx="5734288" cy="1659715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947" y="2104956"/>
            <a:ext cx="2812606" cy="1031607"/>
          </a:xfrm>
        </p:spPr>
        <p:txBody>
          <a:bodyPr anchor="b"/>
          <a:lstStyle>
            <a:lvl1pPr marL="0" indent="0">
              <a:buNone/>
              <a:defRPr sz="1745" b="1"/>
            </a:lvl1pPr>
            <a:lvl2pPr marL="332430" indent="0">
              <a:buNone/>
              <a:defRPr sz="1454" b="1"/>
            </a:lvl2pPr>
            <a:lvl3pPr marL="664860" indent="0">
              <a:buNone/>
              <a:defRPr sz="1309" b="1"/>
            </a:lvl3pPr>
            <a:lvl4pPr marL="997290" indent="0">
              <a:buNone/>
              <a:defRPr sz="1163" b="1"/>
            </a:lvl4pPr>
            <a:lvl5pPr marL="1329720" indent="0">
              <a:buNone/>
              <a:defRPr sz="1163" b="1"/>
            </a:lvl5pPr>
            <a:lvl6pPr marL="1662151" indent="0">
              <a:buNone/>
              <a:defRPr sz="1163" b="1"/>
            </a:lvl6pPr>
            <a:lvl7pPr marL="1994581" indent="0">
              <a:buNone/>
              <a:defRPr sz="1163" b="1"/>
            </a:lvl7pPr>
            <a:lvl8pPr marL="2327011" indent="0">
              <a:buNone/>
              <a:defRPr sz="1163" b="1"/>
            </a:lvl8pPr>
            <a:lvl9pPr marL="2659441" indent="0">
              <a:buNone/>
              <a:defRPr sz="1163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947" y="3136563"/>
            <a:ext cx="2812606" cy="4613411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365778" y="2104956"/>
            <a:ext cx="2826457" cy="1031607"/>
          </a:xfrm>
        </p:spPr>
        <p:txBody>
          <a:bodyPr anchor="b"/>
          <a:lstStyle>
            <a:lvl1pPr marL="0" indent="0">
              <a:buNone/>
              <a:defRPr sz="1745" b="1"/>
            </a:lvl1pPr>
            <a:lvl2pPr marL="332430" indent="0">
              <a:buNone/>
              <a:defRPr sz="1454" b="1"/>
            </a:lvl2pPr>
            <a:lvl3pPr marL="664860" indent="0">
              <a:buNone/>
              <a:defRPr sz="1309" b="1"/>
            </a:lvl3pPr>
            <a:lvl4pPr marL="997290" indent="0">
              <a:buNone/>
              <a:defRPr sz="1163" b="1"/>
            </a:lvl4pPr>
            <a:lvl5pPr marL="1329720" indent="0">
              <a:buNone/>
              <a:defRPr sz="1163" b="1"/>
            </a:lvl5pPr>
            <a:lvl6pPr marL="1662151" indent="0">
              <a:buNone/>
              <a:defRPr sz="1163" b="1"/>
            </a:lvl6pPr>
            <a:lvl7pPr marL="1994581" indent="0">
              <a:buNone/>
              <a:defRPr sz="1163" b="1"/>
            </a:lvl7pPr>
            <a:lvl8pPr marL="2327011" indent="0">
              <a:buNone/>
              <a:defRPr sz="1163" b="1"/>
            </a:lvl8pPr>
            <a:lvl9pPr marL="2659441" indent="0">
              <a:buNone/>
              <a:defRPr sz="1163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365778" y="3136563"/>
            <a:ext cx="2826457" cy="4613411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11BCE-92FE-334C-97EE-9DB94685998F}" type="datetimeFigureOut">
              <a:rPr lang="fr-FR" smtClean="0"/>
              <a:t>15/05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F356F-4C24-8443-96FF-1FFB697E5B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175510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11BCE-92FE-334C-97EE-9DB94685998F}" type="datetimeFigureOut">
              <a:rPr lang="fr-FR" smtClean="0"/>
              <a:t>15/05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F356F-4C24-8443-96FF-1FFB697E5B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397028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11BCE-92FE-334C-97EE-9DB94685998F}" type="datetimeFigureOut">
              <a:rPr lang="fr-FR" smtClean="0"/>
              <a:t>15/05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F356F-4C24-8443-96FF-1FFB697E5B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459303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947" y="572452"/>
            <a:ext cx="2144298" cy="2003584"/>
          </a:xfrm>
        </p:spPr>
        <p:txBody>
          <a:bodyPr anchor="b"/>
          <a:lstStyle>
            <a:lvl1pPr>
              <a:defRPr sz="2327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826457" y="1236340"/>
            <a:ext cx="3365778" cy="6102185"/>
          </a:xfrm>
        </p:spPr>
        <p:txBody>
          <a:bodyPr/>
          <a:lstStyle>
            <a:lvl1pPr>
              <a:defRPr sz="2327"/>
            </a:lvl1pPr>
            <a:lvl2pPr>
              <a:defRPr sz="2036"/>
            </a:lvl2pPr>
            <a:lvl3pPr>
              <a:defRPr sz="1745"/>
            </a:lvl3pPr>
            <a:lvl4pPr>
              <a:defRPr sz="1454"/>
            </a:lvl4pPr>
            <a:lvl5pPr>
              <a:defRPr sz="1454"/>
            </a:lvl5pPr>
            <a:lvl6pPr>
              <a:defRPr sz="1454"/>
            </a:lvl6pPr>
            <a:lvl7pPr>
              <a:defRPr sz="1454"/>
            </a:lvl7pPr>
            <a:lvl8pPr>
              <a:defRPr sz="1454"/>
            </a:lvl8pPr>
            <a:lvl9pPr>
              <a:defRPr sz="1454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947" y="2576036"/>
            <a:ext cx="2144298" cy="4772426"/>
          </a:xfrm>
        </p:spPr>
        <p:txBody>
          <a:bodyPr/>
          <a:lstStyle>
            <a:lvl1pPr marL="0" indent="0">
              <a:buNone/>
              <a:defRPr sz="1163"/>
            </a:lvl1pPr>
            <a:lvl2pPr marL="332430" indent="0">
              <a:buNone/>
              <a:defRPr sz="1018"/>
            </a:lvl2pPr>
            <a:lvl3pPr marL="664860" indent="0">
              <a:buNone/>
              <a:defRPr sz="873"/>
            </a:lvl3pPr>
            <a:lvl4pPr marL="997290" indent="0">
              <a:buNone/>
              <a:defRPr sz="727"/>
            </a:lvl4pPr>
            <a:lvl5pPr marL="1329720" indent="0">
              <a:buNone/>
              <a:defRPr sz="727"/>
            </a:lvl5pPr>
            <a:lvl6pPr marL="1662151" indent="0">
              <a:buNone/>
              <a:defRPr sz="727"/>
            </a:lvl6pPr>
            <a:lvl7pPr marL="1994581" indent="0">
              <a:buNone/>
              <a:defRPr sz="727"/>
            </a:lvl7pPr>
            <a:lvl8pPr marL="2327011" indent="0">
              <a:buNone/>
              <a:defRPr sz="727"/>
            </a:lvl8pPr>
            <a:lvl9pPr marL="2659441" indent="0">
              <a:buNone/>
              <a:defRPr sz="727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11BCE-92FE-334C-97EE-9DB94685998F}" type="datetimeFigureOut">
              <a:rPr lang="fr-FR" smtClean="0"/>
              <a:t>15/05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F356F-4C24-8443-96FF-1FFB697E5B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404896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947" y="572452"/>
            <a:ext cx="2144298" cy="2003584"/>
          </a:xfrm>
        </p:spPr>
        <p:txBody>
          <a:bodyPr anchor="b"/>
          <a:lstStyle>
            <a:lvl1pPr>
              <a:defRPr sz="2327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826457" y="1236340"/>
            <a:ext cx="3365778" cy="6102185"/>
          </a:xfrm>
        </p:spPr>
        <p:txBody>
          <a:bodyPr anchor="t"/>
          <a:lstStyle>
            <a:lvl1pPr marL="0" indent="0">
              <a:buNone/>
              <a:defRPr sz="2327"/>
            </a:lvl1pPr>
            <a:lvl2pPr marL="332430" indent="0">
              <a:buNone/>
              <a:defRPr sz="2036"/>
            </a:lvl2pPr>
            <a:lvl3pPr marL="664860" indent="0">
              <a:buNone/>
              <a:defRPr sz="1745"/>
            </a:lvl3pPr>
            <a:lvl4pPr marL="997290" indent="0">
              <a:buNone/>
              <a:defRPr sz="1454"/>
            </a:lvl4pPr>
            <a:lvl5pPr marL="1329720" indent="0">
              <a:buNone/>
              <a:defRPr sz="1454"/>
            </a:lvl5pPr>
            <a:lvl6pPr marL="1662151" indent="0">
              <a:buNone/>
              <a:defRPr sz="1454"/>
            </a:lvl6pPr>
            <a:lvl7pPr marL="1994581" indent="0">
              <a:buNone/>
              <a:defRPr sz="1454"/>
            </a:lvl7pPr>
            <a:lvl8pPr marL="2327011" indent="0">
              <a:buNone/>
              <a:defRPr sz="1454"/>
            </a:lvl8pPr>
            <a:lvl9pPr marL="2659441" indent="0">
              <a:buNone/>
              <a:defRPr sz="1454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947" y="2576036"/>
            <a:ext cx="2144298" cy="4772426"/>
          </a:xfrm>
        </p:spPr>
        <p:txBody>
          <a:bodyPr/>
          <a:lstStyle>
            <a:lvl1pPr marL="0" indent="0">
              <a:buNone/>
              <a:defRPr sz="1163"/>
            </a:lvl1pPr>
            <a:lvl2pPr marL="332430" indent="0">
              <a:buNone/>
              <a:defRPr sz="1018"/>
            </a:lvl2pPr>
            <a:lvl3pPr marL="664860" indent="0">
              <a:buNone/>
              <a:defRPr sz="873"/>
            </a:lvl3pPr>
            <a:lvl4pPr marL="997290" indent="0">
              <a:buNone/>
              <a:defRPr sz="727"/>
            </a:lvl4pPr>
            <a:lvl5pPr marL="1329720" indent="0">
              <a:buNone/>
              <a:defRPr sz="727"/>
            </a:lvl5pPr>
            <a:lvl6pPr marL="1662151" indent="0">
              <a:buNone/>
              <a:defRPr sz="727"/>
            </a:lvl6pPr>
            <a:lvl7pPr marL="1994581" indent="0">
              <a:buNone/>
              <a:defRPr sz="727"/>
            </a:lvl7pPr>
            <a:lvl8pPr marL="2327011" indent="0">
              <a:buNone/>
              <a:defRPr sz="727"/>
            </a:lvl8pPr>
            <a:lvl9pPr marL="2659441" indent="0">
              <a:buNone/>
              <a:defRPr sz="727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D11BCE-92FE-334C-97EE-9DB94685998F}" type="datetimeFigureOut">
              <a:rPr lang="fr-FR" smtClean="0"/>
              <a:t>15/05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DF356F-4C24-8443-96FF-1FFB697E5B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962779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081" y="457169"/>
            <a:ext cx="5734288" cy="16597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081" y="2285835"/>
            <a:ext cx="5734288" cy="54482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081" y="7958682"/>
            <a:ext cx="1495901" cy="4571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D11BCE-92FE-334C-97EE-9DB94685998F}" type="datetimeFigureOut">
              <a:rPr lang="fr-FR" smtClean="0"/>
              <a:t>15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02299" y="7958682"/>
            <a:ext cx="2243852" cy="4571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695468" y="7958682"/>
            <a:ext cx="1495901" cy="4571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7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DF356F-4C24-8443-96FF-1FFB697E5BD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542516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64860" rtl="0" eaLnBrk="1" latinLnBrk="0" hangingPunct="1">
        <a:lnSpc>
          <a:spcPct val="90000"/>
        </a:lnSpc>
        <a:spcBef>
          <a:spcPct val="0"/>
        </a:spcBef>
        <a:buNone/>
        <a:defRPr sz="319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6215" indent="-166215" algn="l" defTabSz="664860" rtl="0" eaLnBrk="1" latinLnBrk="0" hangingPunct="1">
        <a:lnSpc>
          <a:spcPct val="90000"/>
        </a:lnSpc>
        <a:spcBef>
          <a:spcPts val="727"/>
        </a:spcBef>
        <a:buFont typeface="Arial" panose="020B0604020202020204" pitchFamily="34" charset="0"/>
        <a:buChar char="•"/>
        <a:defRPr sz="2036" kern="1200">
          <a:solidFill>
            <a:schemeClr val="tx1"/>
          </a:solidFill>
          <a:latin typeface="+mn-lt"/>
          <a:ea typeface="+mn-ea"/>
          <a:cs typeface="+mn-cs"/>
        </a:defRPr>
      </a:lvl1pPr>
      <a:lvl2pPr marL="498645" indent="-166215" algn="l" defTabSz="664860" rtl="0" eaLnBrk="1" latinLnBrk="0" hangingPunct="1">
        <a:lnSpc>
          <a:spcPct val="90000"/>
        </a:lnSpc>
        <a:spcBef>
          <a:spcPts val="364"/>
        </a:spcBef>
        <a:buFont typeface="Arial" panose="020B0604020202020204" pitchFamily="34" charset="0"/>
        <a:buChar char="•"/>
        <a:defRPr sz="1745" kern="1200">
          <a:solidFill>
            <a:schemeClr val="tx1"/>
          </a:solidFill>
          <a:latin typeface="+mn-lt"/>
          <a:ea typeface="+mn-ea"/>
          <a:cs typeface="+mn-cs"/>
        </a:defRPr>
      </a:lvl2pPr>
      <a:lvl3pPr marL="831075" indent="-166215" algn="l" defTabSz="664860" rtl="0" eaLnBrk="1" latinLnBrk="0" hangingPunct="1">
        <a:lnSpc>
          <a:spcPct val="90000"/>
        </a:lnSpc>
        <a:spcBef>
          <a:spcPts val="364"/>
        </a:spcBef>
        <a:buFont typeface="Arial" panose="020B0604020202020204" pitchFamily="34" charset="0"/>
        <a:buChar char="•"/>
        <a:defRPr sz="1454" kern="1200">
          <a:solidFill>
            <a:schemeClr val="tx1"/>
          </a:solidFill>
          <a:latin typeface="+mn-lt"/>
          <a:ea typeface="+mn-ea"/>
          <a:cs typeface="+mn-cs"/>
        </a:defRPr>
      </a:lvl3pPr>
      <a:lvl4pPr marL="1163505" indent="-166215" algn="l" defTabSz="664860" rtl="0" eaLnBrk="1" latinLnBrk="0" hangingPunct="1">
        <a:lnSpc>
          <a:spcPct val="90000"/>
        </a:lnSpc>
        <a:spcBef>
          <a:spcPts val="364"/>
        </a:spcBef>
        <a:buFont typeface="Arial" panose="020B0604020202020204" pitchFamily="34" charset="0"/>
        <a:buChar char="•"/>
        <a:defRPr sz="1309" kern="1200">
          <a:solidFill>
            <a:schemeClr val="tx1"/>
          </a:solidFill>
          <a:latin typeface="+mn-lt"/>
          <a:ea typeface="+mn-ea"/>
          <a:cs typeface="+mn-cs"/>
        </a:defRPr>
      </a:lvl4pPr>
      <a:lvl5pPr marL="1495936" indent="-166215" algn="l" defTabSz="664860" rtl="0" eaLnBrk="1" latinLnBrk="0" hangingPunct="1">
        <a:lnSpc>
          <a:spcPct val="90000"/>
        </a:lnSpc>
        <a:spcBef>
          <a:spcPts val="364"/>
        </a:spcBef>
        <a:buFont typeface="Arial" panose="020B0604020202020204" pitchFamily="34" charset="0"/>
        <a:buChar char="•"/>
        <a:defRPr sz="1309" kern="1200">
          <a:solidFill>
            <a:schemeClr val="tx1"/>
          </a:solidFill>
          <a:latin typeface="+mn-lt"/>
          <a:ea typeface="+mn-ea"/>
          <a:cs typeface="+mn-cs"/>
        </a:defRPr>
      </a:lvl5pPr>
      <a:lvl6pPr marL="1828366" indent="-166215" algn="l" defTabSz="664860" rtl="0" eaLnBrk="1" latinLnBrk="0" hangingPunct="1">
        <a:lnSpc>
          <a:spcPct val="90000"/>
        </a:lnSpc>
        <a:spcBef>
          <a:spcPts val="364"/>
        </a:spcBef>
        <a:buFont typeface="Arial" panose="020B0604020202020204" pitchFamily="34" charset="0"/>
        <a:buChar char="•"/>
        <a:defRPr sz="1309" kern="1200">
          <a:solidFill>
            <a:schemeClr val="tx1"/>
          </a:solidFill>
          <a:latin typeface="+mn-lt"/>
          <a:ea typeface="+mn-ea"/>
          <a:cs typeface="+mn-cs"/>
        </a:defRPr>
      </a:lvl6pPr>
      <a:lvl7pPr marL="2160796" indent="-166215" algn="l" defTabSz="664860" rtl="0" eaLnBrk="1" latinLnBrk="0" hangingPunct="1">
        <a:lnSpc>
          <a:spcPct val="90000"/>
        </a:lnSpc>
        <a:spcBef>
          <a:spcPts val="364"/>
        </a:spcBef>
        <a:buFont typeface="Arial" panose="020B0604020202020204" pitchFamily="34" charset="0"/>
        <a:buChar char="•"/>
        <a:defRPr sz="1309" kern="1200">
          <a:solidFill>
            <a:schemeClr val="tx1"/>
          </a:solidFill>
          <a:latin typeface="+mn-lt"/>
          <a:ea typeface="+mn-ea"/>
          <a:cs typeface="+mn-cs"/>
        </a:defRPr>
      </a:lvl7pPr>
      <a:lvl8pPr marL="2493226" indent="-166215" algn="l" defTabSz="664860" rtl="0" eaLnBrk="1" latinLnBrk="0" hangingPunct="1">
        <a:lnSpc>
          <a:spcPct val="90000"/>
        </a:lnSpc>
        <a:spcBef>
          <a:spcPts val="364"/>
        </a:spcBef>
        <a:buFont typeface="Arial" panose="020B0604020202020204" pitchFamily="34" charset="0"/>
        <a:buChar char="•"/>
        <a:defRPr sz="1309" kern="1200">
          <a:solidFill>
            <a:schemeClr val="tx1"/>
          </a:solidFill>
          <a:latin typeface="+mn-lt"/>
          <a:ea typeface="+mn-ea"/>
          <a:cs typeface="+mn-cs"/>
        </a:defRPr>
      </a:lvl8pPr>
      <a:lvl9pPr marL="2825656" indent="-166215" algn="l" defTabSz="664860" rtl="0" eaLnBrk="1" latinLnBrk="0" hangingPunct="1">
        <a:lnSpc>
          <a:spcPct val="90000"/>
        </a:lnSpc>
        <a:spcBef>
          <a:spcPts val="364"/>
        </a:spcBef>
        <a:buFont typeface="Arial" panose="020B0604020202020204" pitchFamily="34" charset="0"/>
        <a:buChar char="•"/>
        <a:defRPr sz="130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64860" rtl="0" eaLnBrk="1" latinLnBrk="0" hangingPunct="1">
        <a:defRPr sz="1309" kern="1200">
          <a:solidFill>
            <a:schemeClr val="tx1"/>
          </a:solidFill>
          <a:latin typeface="+mn-lt"/>
          <a:ea typeface="+mn-ea"/>
          <a:cs typeface="+mn-cs"/>
        </a:defRPr>
      </a:lvl1pPr>
      <a:lvl2pPr marL="332430" algn="l" defTabSz="664860" rtl="0" eaLnBrk="1" latinLnBrk="0" hangingPunct="1">
        <a:defRPr sz="1309" kern="1200">
          <a:solidFill>
            <a:schemeClr val="tx1"/>
          </a:solidFill>
          <a:latin typeface="+mn-lt"/>
          <a:ea typeface="+mn-ea"/>
          <a:cs typeface="+mn-cs"/>
        </a:defRPr>
      </a:lvl2pPr>
      <a:lvl3pPr marL="664860" algn="l" defTabSz="664860" rtl="0" eaLnBrk="1" latinLnBrk="0" hangingPunct="1">
        <a:defRPr sz="1309" kern="1200">
          <a:solidFill>
            <a:schemeClr val="tx1"/>
          </a:solidFill>
          <a:latin typeface="+mn-lt"/>
          <a:ea typeface="+mn-ea"/>
          <a:cs typeface="+mn-cs"/>
        </a:defRPr>
      </a:lvl3pPr>
      <a:lvl4pPr marL="997290" algn="l" defTabSz="664860" rtl="0" eaLnBrk="1" latinLnBrk="0" hangingPunct="1">
        <a:defRPr sz="1309" kern="1200">
          <a:solidFill>
            <a:schemeClr val="tx1"/>
          </a:solidFill>
          <a:latin typeface="+mn-lt"/>
          <a:ea typeface="+mn-ea"/>
          <a:cs typeface="+mn-cs"/>
        </a:defRPr>
      </a:lvl4pPr>
      <a:lvl5pPr marL="1329720" algn="l" defTabSz="664860" rtl="0" eaLnBrk="1" latinLnBrk="0" hangingPunct="1">
        <a:defRPr sz="1309" kern="1200">
          <a:solidFill>
            <a:schemeClr val="tx1"/>
          </a:solidFill>
          <a:latin typeface="+mn-lt"/>
          <a:ea typeface="+mn-ea"/>
          <a:cs typeface="+mn-cs"/>
        </a:defRPr>
      </a:lvl5pPr>
      <a:lvl6pPr marL="1662151" algn="l" defTabSz="664860" rtl="0" eaLnBrk="1" latinLnBrk="0" hangingPunct="1">
        <a:defRPr sz="1309" kern="1200">
          <a:solidFill>
            <a:schemeClr val="tx1"/>
          </a:solidFill>
          <a:latin typeface="+mn-lt"/>
          <a:ea typeface="+mn-ea"/>
          <a:cs typeface="+mn-cs"/>
        </a:defRPr>
      </a:lvl6pPr>
      <a:lvl7pPr marL="1994581" algn="l" defTabSz="664860" rtl="0" eaLnBrk="1" latinLnBrk="0" hangingPunct="1">
        <a:defRPr sz="1309" kern="1200">
          <a:solidFill>
            <a:schemeClr val="tx1"/>
          </a:solidFill>
          <a:latin typeface="+mn-lt"/>
          <a:ea typeface="+mn-ea"/>
          <a:cs typeface="+mn-cs"/>
        </a:defRPr>
      </a:lvl7pPr>
      <a:lvl8pPr marL="2327011" algn="l" defTabSz="664860" rtl="0" eaLnBrk="1" latinLnBrk="0" hangingPunct="1">
        <a:defRPr sz="1309" kern="1200">
          <a:solidFill>
            <a:schemeClr val="tx1"/>
          </a:solidFill>
          <a:latin typeface="+mn-lt"/>
          <a:ea typeface="+mn-ea"/>
          <a:cs typeface="+mn-cs"/>
        </a:defRPr>
      </a:lvl8pPr>
      <a:lvl9pPr marL="2659441" algn="l" defTabSz="664860" rtl="0" eaLnBrk="1" latinLnBrk="0" hangingPunct="1">
        <a:defRPr sz="130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 descr="Une image contenant oiseau, volant, dessin, cerf-volant&#10;&#10;Description générée automatiquement">
            <a:extLst>
              <a:ext uri="{FF2B5EF4-FFF2-40B4-BE49-F238E27FC236}">
                <a16:creationId xmlns:a16="http://schemas.microsoft.com/office/drawing/2014/main" id="{408E694B-73B7-9840-9E68-8F76EEFFB33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6355" t="1832"/>
          <a:stretch/>
        </p:blipFill>
        <p:spPr>
          <a:xfrm rot="509580">
            <a:off x="1082946" y="742173"/>
            <a:ext cx="1611848" cy="5479707"/>
          </a:xfrm>
          <a:prstGeom prst="rect">
            <a:avLst/>
          </a:prstGeom>
        </p:spPr>
      </p:pic>
      <p:sp>
        <p:nvSpPr>
          <p:cNvPr id="2" name="Accolade fermante 1">
            <a:extLst>
              <a:ext uri="{FF2B5EF4-FFF2-40B4-BE49-F238E27FC236}">
                <a16:creationId xmlns:a16="http://schemas.microsoft.com/office/drawing/2014/main" id="{8A902591-052D-6648-924D-7D9F9AB7C16D}"/>
              </a:ext>
            </a:extLst>
          </p:cNvPr>
          <p:cNvSpPr/>
          <p:nvPr/>
        </p:nvSpPr>
        <p:spPr>
          <a:xfrm>
            <a:off x="4227252" y="751528"/>
            <a:ext cx="495300" cy="5500687"/>
          </a:xfrm>
          <a:prstGeom prst="rightBrace">
            <a:avLst>
              <a:gd name="adj1" fmla="val 59181"/>
              <a:gd name="adj2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" name="Connecteur droit 4">
            <a:extLst>
              <a:ext uri="{FF2B5EF4-FFF2-40B4-BE49-F238E27FC236}">
                <a16:creationId xmlns:a16="http://schemas.microsoft.com/office/drawing/2014/main" id="{9F0B2A13-9020-5A4E-817E-A7B8E9F502F1}"/>
              </a:ext>
            </a:extLst>
          </p:cNvPr>
          <p:cNvCxnSpPr>
            <a:cxnSpLocks/>
            <a:stCxn id="3" idx="0"/>
          </p:cNvCxnSpPr>
          <p:nvPr/>
        </p:nvCxnSpPr>
        <p:spPr>
          <a:xfrm flipV="1">
            <a:off x="2293515" y="751526"/>
            <a:ext cx="1877138" cy="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Connecteur droit 6">
            <a:extLst>
              <a:ext uri="{FF2B5EF4-FFF2-40B4-BE49-F238E27FC236}">
                <a16:creationId xmlns:a16="http://schemas.microsoft.com/office/drawing/2014/main" id="{04E4DD42-D700-7147-A27D-F44EB091DD71}"/>
              </a:ext>
            </a:extLst>
          </p:cNvPr>
          <p:cNvCxnSpPr/>
          <p:nvPr/>
        </p:nvCxnSpPr>
        <p:spPr>
          <a:xfrm flipV="1">
            <a:off x="2265896" y="6264785"/>
            <a:ext cx="1908000" cy="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ZoneTexte 5">
            <a:extLst>
              <a:ext uri="{FF2B5EF4-FFF2-40B4-BE49-F238E27FC236}">
                <a16:creationId xmlns:a16="http://schemas.microsoft.com/office/drawing/2014/main" id="{C25EB656-F01C-B144-AF9A-1BC9F0165C38}"/>
              </a:ext>
            </a:extLst>
          </p:cNvPr>
          <p:cNvSpPr txBox="1"/>
          <p:nvPr/>
        </p:nvSpPr>
        <p:spPr>
          <a:xfrm>
            <a:off x="4722554" y="3329626"/>
            <a:ext cx="934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Zone 1</a:t>
            </a:r>
          </a:p>
        </p:txBody>
      </p:sp>
      <p:cxnSp>
        <p:nvCxnSpPr>
          <p:cNvPr id="9" name="Connecteur droit 8">
            <a:extLst>
              <a:ext uri="{FF2B5EF4-FFF2-40B4-BE49-F238E27FC236}">
                <a16:creationId xmlns:a16="http://schemas.microsoft.com/office/drawing/2014/main" id="{984D5069-F5BD-2347-B4E1-1C248F3E289F}"/>
              </a:ext>
            </a:extLst>
          </p:cNvPr>
          <p:cNvCxnSpPr/>
          <p:nvPr/>
        </p:nvCxnSpPr>
        <p:spPr>
          <a:xfrm flipV="1">
            <a:off x="2293515" y="942026"/>
            <a:ext cx="900000" cy="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Accolade fermante 10">
            <a:extLst>
              <a:ext uri="{FF2B5EF4-FFF2-40B4-BE49-F238E27FC236}">
                <a16:creationId xmlns:a16="http://schemas.microsoft.com/office/drawing/2014/main" id="{DB3F8605-82AD-B744-B1C0-45A4929C92FB}"/>
              </a:ext>
            </a:extLst>
          </p:cNvPr>
          <p:cNvSpPr/>
          <p:nvPr/>
        </p:nvSpPr>
        <p:spPr>
          <a:xfrm>
            <a:off x="3229103" y="759149"/>
            <a:ext cx="100175" cy="177942"/>
          </a:xfrm>
          <a:prstGeom prst="rightBrace">
            <a:avLst>
              <a:gd name="adj1" fmla="val 59181"/>
              <a:gd name="adj2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AA810BA7-6A0F-3645-A954-751A98BA3F11}"/>
              </a:ext>
            </a:extLst>
          </p:cNvPr>
          <p:cNvSpPr txBox="1"/>
          <p:nvPr/>
        </p:nvSpPr>
        <p:spPr>
          <a:xfrm>
            <a:off x="3282417" y="683287"/>
            <a:ext cx="934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Zone 3</a:t>
            </a:r>
          </a:p>
        </p:txBody>
      </p:sp>
      <p:cxnSp>
        <p:nvCxnSpPr>
          <p:cNvPr id="13" name="Connecteur droit 12">
            <a:extLst>
              <a:ext uri="{FF2B5EF4-FFF2-40B4-BE49-F238E27FC236}">
                <a16:creationId xmlns:a16="http://schemas.microsoft.com/office/drawing/2014/main" id="{80A28A8F-B8A7-FE40-863A-C794592FBFC1}"/>
              </a:ext>
            </a:extLst>
          </p:cNvPr>
          <p:cNvCxnSpPr/>
          <p:nvPr/>
        </p:nvCxnSpPr>
        <p:spPr>
          <a:xfrm flipV="1">
            <a:off x="2408747" y="2857556"/>
            <a:ext cx="809177" cy="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Accolade fermante 13">
            <a:extLst>
              <a:ext uri="{FF2B5EF4-FFF2-40B4-BE49-F238E27FC236}">
                <a16:creationId xmlns:a16="http://schemas.microsoft.com/office/drawing/2014/main" id="{18AB7BD9-2C98-6B4D-8CA8-B1759B588097}"/>
              </a:ext>
            </a:extLst>
          </p:cNvPr>
          <p:cNvSpPr/>
          <p:nvPr/>
        </p:nvSpPr>
        <p:spPr>
          <a:xfrm>
            <a:off x="3231223" y="962326"/>
            <a:ext cx="157817" cy="1895227"/>
          </a:xfrm>
          <a:prstGeom prst="rightBrace">
            <a:avLst>
              <a:gd name="adj1" fmla="val 59181"/>
              <a:gd name="adj2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814079F1-C367-D840-A72C-8DBA0AA0931C}"/>
              </a:ext>
            </a:extLst>
          </p:cNvPr>
          <p:cNvSpPr txBox="1"/>
          <p:nvPr/>
        </p:nvSpPr>
        <p:spPr>
          <a:xfrm>
            <a:off x="3389040" y="1725271"/>
            <a:ext cx="934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Zone 2</a:t>
            </a:r>
          </a:p>
        </p:txBody>
      </p:sp>
      <p:sp>
        <p:nvSpPr>
          <p:cNvPr id="16" name="Accolade fermante 15">
            <a:extLst>
              <a:ext uri="{FF2B5EF4-FFF2-40B4-BE49-F238E27FC236}">
                <a16:creationId xmlns:a16="http://schemas.microsoft.com/office/drawing/2014/main" id="{596A0C8D-D48B-9F4D-94D5-4C08A06022E2}"/>
              </a:ext>
            </a:extLst>
          </p:cNvPr>
          <p:cNvSpPr/>
          <p:nvPr/>
        </p:nvSpPr>
        <p:spPr>
          <a:xfrm>
            <a:off x="3252843" y="2883684"/>
            <a:ext cx="136197" cy="3368531"/>
          </a:xfrm>
          <a:prstGeom prst="rightBrace">
            <a:avLst>
              <a:gd name="adj1" fmla="val 59181"/>
              <a:gd name="adj2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50D8FA41-9029-E84A-A35E-9C65E194B559}"/>
              </a:ext>
            </a:extLst>
          </p:cNvPr>
          <p:cNvSpPr txBox="1"/>
          <p:nvPr/>
        </p:nvSpPr>
        <p:spPr>
          <a:xfrm>
            <a:off x="3399876" y="4405347"/>
            <a:ext cx="934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>
                <a:latin typeface="Times New Roman" panose="02020603050405020304" pitchFamily="18" charset="0"/>
                <a:cs typeface="Times New Roman" panose="02020603050405020304" pitchFamily="18" charset="0"/>
              </a:rPr>
              <a:t>Zone 4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315078A9-4135-0244-B480-046B833BD236}"/>
              </a:ext>
            </a:extLst>
          </p:cNvPr>
          <p:cNvSpPr txBox="1"/>
          <p:nvPr/>
        </p:nvSpPr>
        <p:spPr>
          <a:xfrm>
            <a:off x="392028" y="6885806"/>
            <a:ext cx="557721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finition of the different zones of the primary roo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Zone 1 is the length of primary root (L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Zone 2 is delimited between the first and last lateral roots, zone 3 between the hypocotyl junction and the first lateral root, and zone 4 between the last lateral root and the primary root tip.</a:t>
            </a:r>
            <a:r>
              <a:rPr lang="fr-B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192642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</TotalTime>
  <Words>70</Words>
  <Application>Microsoft Macintosh PowerPoint</Application>
  <PresentationFormat>Personnalisé</PresentationFormat>
  <Paragraphs>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ulien LOUVIEAUX</dc:creator>
  <cp:lastModifiedBy>Julien LOUVIEAUX</cp:lastModifiedBy>
  <cp:revision>12</cp:revision>
  <dcterms:created xsi:type="dcterms:W3CDTF">2019-12-30T14:52:11Z</dcterms:created>
  <dcterms:modified xsi:type="dcterms:W3CDTF">2020-05-15T10:05:45Z</dcterms:modified>
</cp:coreProperties>
</file>